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D35DB-A5CF-A576-B95A-BAD8BCEBA6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16783D5-BF1C-C174-EA04-1F833CFB04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9E60F7-7482-E8D5-67EC-B78968E27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82C955-1687-EC98-9C1E-E27DF6A57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AF26A3-B8E9-D14A-761E-6E9C53D34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A5BA6B-5425-D943-3617-85F47CD5D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9EF282-31C1-B86F-8F70-DF5BBE45FA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E44D9-96DF-D4D7-8A69-7D2218B55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0E6578-EA99-28E8-40F5-41CE699EA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10A033-F490-38C1-7262-8D11110C5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024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51CAED-56AE-1808-EE8B-8671740279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0D9B8E-8FAF-E4F8-980A-6E30B46B4C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4B6CCB-DAEB-A26C-A0F3-60300A459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BF5B0-53DA-B574-1DDF-E2CFEF9E9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0CD713-46B7-6E95-9218-7FA69BFDF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734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EC203B-04DE-3D98-3858-8CF725CF9F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65D602-F804-0E27-A9EB-B0B4FAB0D4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9C744-EFC2-6CE8-E6AF-FF375D62D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215CDF-A402-7F05-DCA5-DAE3F2513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61323C-D687-AF4E-9984-E2A516162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47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685BBF-AE91-B022-6081-7B46F08BE5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5A47F1-0815-EFC3-9882-65001B0AFF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9AC36C-7969-2075-4C69-9382711DC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1FCA6C-D114-CCB0-2618-2C09196A4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D2A6C9-27DF-D564-01F0-66C6C61FF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913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A7DCA-34D8-C1A2-9918-13B6C032A3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64C8C6-4592-AF84-A215-6334DDC2C4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6969E0-4A10-02DA-9997-A717EA3623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4ACBD1-947C-6C76-F28A-837AC39A2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F74315-7D2F-1DAC-1CB3-3EE2B541E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0B9AC5-CBBC-40FB-AFFE-44D165156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052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69301-F21A-E270-145B-B9AE2C014D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33FA0D-95CB-7201-00DC-B431772FA3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E9AC91-B22F-ED64-A8E0-1EC64C0550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B14AC8-3904-956A-DE95-3A2710C963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85C1FE-9EAC-EC8A-F7B3-428964C526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5B4962-495B-4226-AB41-41B565E6E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2930FF-328C-8541-8FC4-761B2AC66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4F3B3D-701E-F831-737E-CB3C9DDF3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722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2FC06-7598-B501-21E6-8BBEC531C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B7B984-E8E3-B791-3176-A1DB4B2AA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1C5474-23E2-9BCD-AC61-D1460961A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9C55384-7FA4-2FAC-E3B2-716ABE878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692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BF88FB-99A7-B555-C61F-531348C4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41AB98-6211-7A82-C88D-955DDBB06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A2271A-4867-0A33-F901-67C211CD4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695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6276E-5BB0-7939-E5D0-D54FE2451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C1F5B7-9C0F-FD1B-FED9-CA62C1FD35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AD7A4D-DFDD-7E1F-2128-2DC8D1EFD1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7D047D-421B-7C4E-E194-0A3056CD4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EBC361-D34C-9DA0-5191-0AA63C7FE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FF9C99-8043-7379-23F4-05D14105A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596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B6206B-D696-1EFA-F7BA-5BAE647502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F18A288-032A-1B89-2BA1-1B04A17BF6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FCC1F1-0973-BF41-5FF7-8A4A815D78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6DC178-7851-E886-4773-D8FFC7292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1EFB17-E6B3-169C-483B-4985025FF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4E184B-88A1-EFFD-C042-2AA220996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798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C1B9D9-4956-4B7D-3E72-A1C3CB087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FCAF8C-3EBB-10C9-6A57-6969B6CA18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5947F8-961C-2C2D-2569-9477C0B465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813A7A-1011-4345-AD88-7BB72DD45721}" type="datetimeFigureOut">
              <a:rPr lang="en-US" smtClean="0"/>
              <a:t>1/2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CDE60B-6CAC-1ED4-2D1C-3C130858FE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8068E-BA11-B16F-39D1-B8A3334D45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09BB26-C962-4AAD-8B84-CEE74D2448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879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4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3.png"/><Relationship Id="rId17" Type="http://schemas.openxmlformats.org/officeDocument/2006/relationships/image" Target="../media/image8.png"/><Relationship Id="rId2" Type="http://schemas.openxmlformats.org/officeDocument/2006/relationships/video" Target="../media/media1.mp4"/><Relationship Id="rId16" Type="http://schemas.openxmlformats.org/officeDocument/2006/relationships/image" Target="../media/image7.JPG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2.png"/><Relationship Id="rId5" Type="http://schemas.microsoft.com/office/2007/relationships/media" Target="../media/media3.mp4"/><Relationship Id="rId15" Type="http://schemas.openxmlformats.org/officeDocument/2006/relationships/image" Target="../media/image6.JPG"/><Relationship Id="rId10" Type="http://schemas.openxmlformats.org/officeDocument/2006/relationships/image" Target="../media/image1.png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7.xml"/><Relationship Id="rId14" Type="http://schemas.openxmlformats.org/officeDocument/2006/relationships/image" Target="../media/image5.JP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6.mp4"/><Relationship Id="rId7" Type="http://schemas.openxmlformats.org/officeDocument/2006/relationships/image" Target="../media/image10.png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6" Type="http://schemas.openxmlformats.org/officeDocument/2006/relationships/image" Target="../media/image9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6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BFAE2AF-396B-835B-63B4-270BCB775B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014" y="131024"/>
            <a:ext cx="351857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latinLnBrk="0"/>
            <a:r>
              <a:rPr kumimoji="0" lang="en-GB" altLang="ko-KR" sz="2000" dirty="0">
                <a:latin typeface="Arial" panose="020B0604020202020204" pitchFamily="34" charset="0"/>
                <a:cs typeface="Times New Roman" panose="02020603050405020304" pitchFamily="18" charset="0"/>
              </a:rPr>
              <a:t>Supplementary Video 1</a:t>
            </a:r>
            <a:endParaRPr kumimoji="0" lang="en-GB" altLang="ko-KR" sz="2000" dirty="0"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B430EAC-F266-1364-2A0E-04F4EB6CBDA0}"/>
              </a:ext>
            </a:extLst>
          </p:cNvPr>
          <p:cNvSpPr txBox="1"/>
          <p:nvPr/>
        </p:nvSpPr>
        <p:spPr>
          <a:xfrm>
            <a:off x="3399465" y="953150"/>
            <a:ext cx="1089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A3F59CD-2ED5-2B51-24AF-7379D1A92B7F}"/>
              </a:ext>
            </a:extLst>
          </p:cNvPr>
          <p:cNvSpPr txBox="1"/>
          <p:nvPr/>
        </p:nvSpPr>
        <p:spPr>
          <a:xfrm>
            <a:off x="3399465" y="3854648"/>
            <a:ext cx="1089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apb C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F3A354-616D-B49E-D887-44F1B07C3E9C}"/>
              </a:ext>
            </a:extLst>
          </p:cNvPr>
          <p:cNvSpPr txBox="1"/>
          <p:nvPr/>
        </p:nvSpPr>
        <p:spPr>
          <a:xfrm>
            <a:off x="6914609" y="3854648"/>
            <a:ext cx="224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apb CR – 15mM PTZ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138332-3B6F-3DB6-0B54-AFCD3452B595}"/>
              </a:ext>
            </a:extLst>
          </p:cNvPr>
          <p:cNvSpPr txBox="1"/>
          <p:nvPr/>
        </p:nvSpPr>
        <p:spPr>
          <a:xfrm>
            <a:off x="6914609" y="953150"/>
            <a:ext cx="224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 – 15mM PTZ</a:t>
            </a:r>
          </a:p>
        </p:txBody>
      </p:sp>
      <p:pic>
        <p:nvPicPr>
          <p:cNvPr id="7" name="Trial 12_C_C3">
            <a:hlinkClick r:id="" action="ppaction://media"/>
            <a:extLst>
              <a:ext uri="{FF2B5EF4-FFF2-40B4-BE49-F238E27FC236}">
                <a16:creationId xmlns:a16="http://schemas.microsoft.com/office/drawing/2014/main" id="{2A3CBBB1-815F-FF03-E164-DFDA3A533C1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0">
            <a:lum bright="-20000" contrast="-40000"/>
          </a:blip>
          <a:stretch>
            <a:fillRect/>
          </a:stretch>
        </p:blipFill>
        <p:spPr>
          <a:xfrm>
            <a:off x="2191889" y="1260927"/>
            <a:ext cx="1645920" cy="1645920"/>
          </a:xfrm>
          <a:prstGeom prst="rect">
            <a:avLst/>
          </a:prstGeom>
        </p:spPr>
      </p:pic>
      <p:pic>
        <p:nvPicPr>
          <p:cNvPr id="8" name="Trial 12_Napb_A4">
            <a:hlinkClick r:id="" action="ppaction://media"/>
            <a:extLst>
              <a:ext uri="{FF2B5EF4-FFF2-40B4-BE49-F238E27FC236}">
                <a16:creationId xmlns:a16="http://schemas.microsoft.com/office/drawing/2014/main" id="{0F9FCB9B-D0E9-F314-E812-CD51F8F5629D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>
            <a:lum contrast="-40000"/>
          </a:blip>
          <a:stretch>
            <a:fillRect/>
          </a:stretch>
        </p:blipFill>
        <p:spPr>
          <a:xfrm>
            <a:off x="2196018" y="4172688"/>
            <a:ext cx="1645920" cy="1645920"/>
          </a:xfrm>
          <a:prstGeom prst="rect">
            <a:avLst/>
          </a:prstGeom>
        </p:spPr>
      </p:pic>
      <p:pic>
        <p:nvPicPr>
          <p:cNvPr id="9" name="Trial 16 _PTZ 15mM_Napb_A1">
            <a:hlinkClick r:id="" action="ppaction://media"/>
            <a:extLst>
              <a:ext uri="{FF2B5EF4-FFF2-40B4-BE49-F238E27FC236}">
                <a16:creationId xmlns:a16="http://schemas.microsoft.com/office/drawing/2014/main" id="{99E5EAC8-20D1-1AC3-B6A1-518DE915C89C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>
            <a:lum contrast="-40000"/>
          </a:blip>
          <a:stretch>
            <a:fillRect/>
          </a:stretch>
        </p:blipFill>
        <p:spPr>
          <a:xfrm>
            <a:off x="6097705" y="4172688"/>
            <a:ext cx="1645920" cy="1645920"/>
          </a:xfrm>
          <a:prstGeom prst="rect">
            <a:avLst/>
          </a:prstGeom>
        </p:spPr>
      </p:pic>
      <p:pic>
        <p:nvPicPr>
          <p:cNvPr id="10" name="Trial 16_PTZ 15mM_C_D6">
            <a:hlinkClick r:id="" action="ppaction://media"/>
            <a:extLst>
              <a:ext uri="{FF2B5EF4-FFF2-40B4-BE49-F238E27FC236}">
                <a16:creationId xmlns:a16="http://schemas.microsoft.com/office/drawing/2014/main" id="{C55DFCBF-0ED8-1AA6-BAA2-8C75CA5172FE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3">
            <a:lum contrast="-40000"/>
          </a:blip>
          <a:stretch>
            <a:fillRect/>
          </a:stretch>
        </p:blipFill>
        <p:spPr>
          <a:xfrm>
            <a:off x="6091649" y="1260927"/>
            <a:ext cx="1645920" cy="16459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63F8471-BE89-D05A-F0A7-1AE693CE1E6D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7" r="4902" b="5111"/>
          <a:stretch/>
        </p:blipFill>
        <p:spPr>
          <a:xfrm>
            <a:off x="4014558" y="4172688"/>
            <a:ext cx="1646940" cy="16459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CD4C014-3F26-27EA-9763-CAB3289867F2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8" t="4249"/>
          <a:stretch/>
        </p:blipFill>
        <p:spPr>
          <a:xfrm>
            <a:off x="7906059" y="1260927"/>
            <a:ext cx="1656105" cy="16459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24F1524-ABCF-6DD1-5B64-2ABEC2BCAEAF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6" t="3055" r="2746" b="3878"/>
          <a:stretch/>
        </p:blipFill>
        <p:spPr>
          <a:xfrm>
            <a:off x="7916244" y="4184972"/>
            <a:ext cx="1645920" cy="162135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B77DB7C-69FA-BF28-FDF4-667DA005DD1D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3" t="7595" r="6608" b="9670"/>
          <a:stretch/>
        </p:blipFill>
        <p:spPr>
          <a:xfrm>
            <a:off x="4020045" y="1260927"/>
            <a:ext cx="1645919" cy="1645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87710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video>
              <p:cMediaNode vol="80000">
                <p:cTn id="23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video>
              <p:cMediaNode vol="80000">
                <p:cTn id="24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video>
              <p:cMediaNode vol="80000">
                <p:cTn id="25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97">
            <a:extLst>
              <a:ext uri="{FF2B5EF4-FFF2-40B4-BE49-F238E27FC236}">
                <a16:creationId xmlns:a16="http://schemas.microsoft.com/office/drawing/2014/main" id="{A33C7137-2147-ED80-A37C-2D8F9D3E33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6232" y="1257011"/>
            <a:ext cx="1206731" cy="346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algn="ctr" defTabSz="753923" eaLnBrk="1" hangingPunct="1">
              <a:defRPr/>
            </a:pPr>
            <a:r>
              <a:rPr lang="en-US" altLang="x-none" sz="1649" kern="0" dirty="0">
                <a:solidFill>
                  <a:prstClr val="black"/>
                </a:solidFill>
              </a:rPr>
              <a:t>Control</a:t>
            </a:r>
            <a:endParaRPr lang="fr-FR" altLang="x-none" sz="1649" kern="0" dirty="0">
              <a:solidFill>
                <a:prstClr val="black"/>
              </a:solidFill>
            </a:endParaRPr>
          </a:p>
        </p:txBody>
      </p:sp>
      <p:sp>
        <p:nvSpPr>
          <p:cNvPr id="3" name="Text Box 97">
            <a:extLst>
              <a:ext uri="{FF2B5EF4-FFF2-40B4-BE49-F238E27FC236}">
                <a16:creationId xmlns:a16="http://schemas.microsoft.com/office/drawing/2014/main" id="{6499E485-47D3-3824-08E3-A6F03CADA3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1072" y="1257011"/>
            <a:ext cx="1473427" cy="346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algn="ctr" defTabSz="753923" eaLnBrk="1" hangingPunct="1">
              <a:defRPr/>
            </a:pPr>
            <a:r>
              <a:rPr lang="en-US" altLang="x-none" sz="1649" kern="0" dirty="0" err="1">
                <a:solidFill>
                  <a:prstClr val="black"/>
                </a:solidFill>
              </a:rPr>
              <a:t>napb</a:t>
            </a:r>
            <a:r>
              <a:rPr lang="en-US" altLang="x-none" sz="1649" kern="0" dirty="0">
                <a:solidFill>
                  <a:prstClr val="black"/>
                </a:solidFill>
              </a:rPr>
              <a:t> CR</a:t>
            </a:r>
            <a:endParaRPr lang="fr-FR" altLang="x-none" sz="1649" kern="0" dirty="0">
              <a:solidFill>
                <a:prstClr val="black"/>
              </a:solidFill>
            </a:endParaRPr>
          </a:p>
        </p:txBody>
      </p:sp>
      <p:pic>
        <p:nvPicPr>
          <p:cNvPr id="5" name="NAPB_1">
            <a:hlinkClick r:id="" action="ppaction://media"/>
            <a:extLst>
              <a:ext uri="{FF2B5EF4-FFF2-40B4-BE49-F238E27FC236}">
                <a16:creationId xmlns:a16="http://schemas.microsoft.com/office/drawing/2014/main" id="{B56A2C55-D821-6E81-86C1-03BA4F9E077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>
            <a:lum bright="10000"/>
          </a:blip>
          <a:stretch>
            <a:fillRect/>
          </a:stretch>
        </p:blipFill>
        <p:spPr>
          <a:xfrm>
            <a:off x="6471835" y="1845091"/>
            <a:ext cx="3771900" cy="3771900"/>
          </a:xfrm>
          <a:prstGeom prst="rect">
            <a:avLst/>
          </a:prstGeom>
        </p:spPr>
      </p:pic>
      <p:pic>
        <p:nvPicPr>
          <p:cNvPr id="4" name="CTR_3">
            <a:hlinkClick r:id="" action="ppaction://media"/>
            <a:extLst>
              <a:ext uri="{FF2B5EF4-FFF2-40B4-BE49-F238E27FC236}">
                <a16:creationId xmlns:a16="http://schemas.microsoft.com/office/drawing/2014/main" id="{8917A40B-2334-5F00-8E73-87BDD6628619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lum bright="10000"/>
          </a:blip>
          <a:stretch>
            <a:fillRect/>
          </a:stretch>
        </p:blipFill>
        <p:spPr>
          <a:xfrm>
            <a:off x="1346261" y="1799403"/>
            <a:ext cx="3797389" cy="381758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0B69EB0-4C5B-A54B-41EE-2791E00D6F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014" y="131024"/>
            <a:ext cx="351857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latinLnBrk="0"/>
            <a:r>
              <a:rPr kumimoji="0" lang="en-GB" altLang="ko-KR" sz="2000" dirty="0">
                <a:latin typeface="Arial" panose="020B0604020202020204" pitchFamily="34" charset="0"/>
                <a:cs typeface="Times New Roman" panose="02020603050405020304" pitchFamily="18" charset="0"/>
              </a:rPr>
              <a:t>Supplementary Video 1</a:t>
            </a:r>
            <a:endParaRPr kumimoji="0" lang="en-GB" altLang="ko-KR" sz="20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7590253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repeatCount="indefinite" fill="remove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3" repeatCount="indefinite" fill="remove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21</Words>
  <Application>Microsoft Office PowerPoint</Application>
  <PresentationFormat>Widescreen</PresentationFormat>
  <Paragraphs>8</Paragraphs>
  <Slides>2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. Yongsoo Park</dc:creator>
  <cp:lastModifiedBy>Dr. Yongsoo Park</cp:lastModifiedBy>
  <cp:revision>4</cp:revision>
  <dcterms:created xsi:type="dcterms:W3CDTF">2025-01-07T09:40:16Z</dcterms:created>
  <dcterms:modified xsi:type="dcterms:W3CDTF">2025-01-26T11:00:56Z</dcterms:modified>
</cp:coreProperties>
</file>